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799763" cy="432069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2F6FE-4747-4DE2-8C98-51F312D970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9720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9280" y="24973920"/>
            <a:ext cx="9720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80162-0E46-4B1A-B816-2F63C89D6E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20240" y="1008036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9280" y="2497392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20240" y="2497392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4FC9C-8FA1-418F-B758-881BD52F26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312984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26080" y="10080360"/>
            <a:ext cx="312984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12880" y="10080360"/>
            <a:ext cx="312984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9280" y="24973920"/>
            <a:ext cx="312984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26080" y="24973920"/>
            <a:ext cx="312984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12880" y="24973920"/>
            <a:ext cx="312984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0F54D-65CC-4A0B-9E34-7E0A018BA3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9280" y="10080360"/>
            <a:ext cx="9720360" cy="28514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792805-A0F7-45F8-9D65-C1F94D336A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9720360" cy="285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D83C8-1DE6-4B26-92FE-F9E3DDEBCE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4743360" cy="285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20240" y="10080360"/>
            <a:ext cx="4743360" cy="285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AF2D9-4A4D-47FD-963A-67F41CCE72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A7A04-7651-4E94-871A-2FCC394B04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9280" y="1730520"/>
            <a:ext cx="9720360" cy="3337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8E4148-46EC-4A09-8158-B2BA5ECE14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20240" y="10080360"/>
            <a:ext cx="4743360" cy="285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9280" y="2497392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C03AA-0827-4F9E-86F6-5B0A642821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4743360" cy="285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20240" y="1008036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20240" y="2497392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9C245-E3BD-47CB-A64F-1C87B71074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9280" y="1008036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20240" y="10080360"/>
            <a:ext cx="4743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9280" y="24973920"/>
            <a:ext cx="9720360" cy="13601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2D68A4-D9BA-445B-86F7-17E8B4B465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9280" y="1730520"/>
            <a:ext cx="9720360" cy="72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9280" y="10080360"/>
            <a:ext cx="9720360" cy="285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9280" y="40044600"/>
            <a:ext cx="2521080" cy="2300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688920" y="40044600"/>
            <a:ext cx="3421080" cy="2300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38560" y="40044600"/>
            <a:ext cx="2521080" cy="2300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6957215-9830-402E-84B1-E887CCAEA89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95"/>
          <p:cNvGrpSpPr/>
          <p:nvPr/>
        </p:nvGrpSpPr>
        <p:grpSpPr>
          <a:xfrm>
            <a:off x="25560" y="318960"/>
            <a:ext cx="10824840" cy="41784840"/>
            <a:chOff x="25560" y="318960"/>
            <a:chExt cx="10824840" cy="41784840"/>
          </a:xfrm>
        </p:grpSpPr>
        <p:grpSp>
          <p:nvGrpSpPr>
            <p:cNvPr id="42" name="组 7"/>
            <p:cNvGrpSpPr/>
            <p:nvPr/>
          </p:nvGrpSpPr>
          <p:grpSpPr>
            <a:xfrm>
              <a:off x="25560" y="318960"/>
              <a:ext cx="10824840" cy="41685120"/>
              <a:chOff x="25560" y="318960"/>
              <a:chExt cx="10824840" cy="41685120"/>
            </a:xfrm>
          </p:grpSpPr>
          <p:grpSp>
            <p:nvGrpSpPr>
              <p:cNvPr id="43" name="组 41"/>
              <p:cNvGrpSpPr/>
              <p:nvPr/>
            </p:nvGrpSpPr>
            <p:grpSpPr>
              <a:xfrm>
                <a:off x="25560" y="318960"/>
                <a:ext cx="10824840" cy="41674320"/>
                <a:chOff x="25560" y="318960"/>
                <a:chExt cx="10824840" cy="41674320"/>
              </a:xfrm>
            </p:grpSpPr>
            <p:grpSp>
              <p:nvGrpSpPr>
                <p:cNvPr id="44" name="组 32"/>
                <p:cNvGrpSpPr/>
                <p:nvPr/>
              </p:nvGrpSpPr>
              <p:grpSpPr>
                <a:xfrm>
                  <a:off x="25560" y="318960"/>
                  <a:ext cx="10824840" cy="41674320"/>
                  <a:chOff x="25560" y="318960"/>
                  <a:chExt cx="10824840" cy="41674320"/>
                </a:xfrm>
              </p:grpSpPr>
              <p:pic>
                <p:nvPicPr>
                  <p:cNvPr id="45" name="图片 4" descr="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1143000" y="318960"/>
                    <a:ext cx="8851680" cy="41674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6" name="文本框 5"/>
                  <p:cNvSpPr/>
                  <p:nvPr/>
                </p:nvSpPr>
                <p:spPr>
                  <a:xfrm>
                    <a:off x="799920" y="41676120"/>
                    <a:ext cx="5968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G1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" name="文本框 6"/>
                  <p:cNvSpPr/>
                  <p:nvPr/>
                </p:nvSpPr>
                <p:spPr>
                  <a:xfrm>
                    <a:off x="787320" y="41244120"/>
                    <a:ext cx="5968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G2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" name="文本框 7"/>
                  <p:cNvSpPr/>
                  <p:nvPr/>
                </p:nvSpPr>
                <p:spPr>
                  <a:xfrm>
                    <a:off x="1002960" y="41624280"/>
                    <a:ext cx="295200" cy="3682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zh-CN" sz="1800" spc="-1" strike="noStrike">
                        <a:solidFill>
                          <a:srgbClr val="ff0000"/>
                        </a:solidFill>
                        <a:latin typeface="Calibri"/>
                      </a:rPr>
                      <a:t>&gt;</a:t>
                    </a: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" name="文本框 8"/>
                  <p:cNvSpPr/>
                  <p:nvPr/>
                </p:nvSpPr>
                <p:spPr>
                  <a:xfrm>
                    <a:off x="1015920" y="41217840"/>
                    <a:ext cx="295200" cy="3682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zh-CN" sz="1800" spc="-1" strike="noStrike">
                        <a:solidFill>
                          <a:srgbClr val="ff0000"/>
                        </a:solidFill>
                        <a:latin typeface="Calibri"/>
                      </a:rPr>
                      <a:t>&gt;</a:t>
                    </a: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" name="文本框 11"/>
                  <p:cNvSpPr/>
                  <p:nvPr/>
                </p:nvSpPr>
                <p:spPr>
                  <a:xfrm>
                    <a:off x="3035880" y="15957000"/>
                    <a:ext cx="295200" cy="3682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zh-CN" sz="1800" spc="-1" strike="noStrike">
                        <a:solidFill>
                          <a:srgbClr val="0000ff"/>
                        </a:solidFill>
                        <a:latin typeface="Calibri"/>
                      </a:rPr>
                      <a:t>&gt;</a:t>
                    </a: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" name="直接连接符 22"/>
                  <p:cNvSpPr/>
                  <p:nvPr/>
                </p:nvSpPr>
                <p:spPr>
                  <a:xfrm>
                    <a:off x="25560" y="19100880"/>
                    <a:ext cx="10799640" cy="31680"/>
                  </a:xfrm>
                  <a:prstGeom prst="line">
                    <a:avLst/>
                  </a:prstGeom>
                  <a:ln w="12600">
                    <a:solidFill>
                      <a:srgbClr val="4f81bd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120" bIns="-151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" name="直接连接符 22"/>
                  <p:cNvSpPr/>
                  <p:nvPr/>
                </p:nvSpPr>
                <p:spPr>
                  <a:xfrm>
                    <a:off x="50760" y="35420760"/>
                    <a:ext cx="10799640" cy="31680"/>
                  </a:xfrm>
                  <a:prstGeom prst="line">
                    <a:avLst/>
                  </a:prstGeom>
                  <a:ln w="12600">
                    <a:solidFill>
                      <a:srgbClr val="4f81bd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120" bIns="-151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" name="右大括号 18"/>
                  <p:cNvSpPr/>
                  <p:nvPr/>
                </p:nvSpPr>
                <p:spPr>
                  <a:xfrm>
                    <a:off x="8921880" y="628200"/>
                    <a:ext cx="260280" cy="2869920"/>
                  </a:xfrm>
                  <a:custGeom>
                    <a:avLst/>
                    <a:gdLst>
                      <a:gd name="textAreaLeft" fmla="*/ 0 w 260280"/>
                      <a:gd name="textAreaRight" fmla="*/ 93960 w 260280"/>
                      <a:gd name="textAreaTop" fmla="*/ 6480 h 2869920"/>
                      <a:gd name="textAreaBottom" fmla="*/ 2863440 h 28699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82"/>
                          <a:pt x="10800" y="163"/>
                        </a:cubicBezTo>
                        <a:lnTo>
                          <a:pt x="10800" y="10637"/>
                        </a:lnTo>
                        <a:cubicBezTo>
                          <a:pt x="10800" y="10719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0882"/>
                          <a:pt x="10800" y="10963"/>
                        </a:cubicBezTo>
                        <a:lnTo>
                          <a:pt x="10800" y="21437"/>
                        </a:lnTo>
                        <a:cubicBezTo>
                          <a:pt x="10800" y="21519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25560">
                    <a:solidFill>
                      <a:srgbClr val="800000"/>
                    </a:solidFill>
                    <a:miter/>
                  </a:ln>
                  <a:effectLst>
                    <a:outerShdw dist="20160" dir="5400000" blurRad="0" rotWithShape="0">
                      <a:srgbClr val="808080">
                        <a:alpha val="38000"/>
                      </a:srgbClr>
                    </a:outerShdw>
                  </a:effectLst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" name="TextBox 16"/>
                  <p:cNvSpPr/>
                  <p:nvPr/>
                </p:nvSpPr>
                <p:spPr>
                  <a:xfrm>
                    <a:off x="9205920" y="1887120"/>
                    <a:ext cx="1277640" cy="307080"/>
                  </a:xfrm>
                  <a:prstGeom prst="rect">
                    <a:avLst/>
                  </a:prstGeom>
                  <a:solidFill>
                    <a:srgbClr val="dce6f2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400" spc="-1" strike="noStrike">
                        <a:solidFill>
                          <a:srgbClr val="0000ff"/>
                        </a:solidFill>
                        <a:latin typeface="Times New Roman"/>
                        <a:ea typeface="Times New Roman"/>
                      </a:rPr>
                      <a:t>Or-Yu_Lu_Str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" name="右大括号 20"/>
                  <p:cNvSpPr/>
                  <p:nvPr/>
                </p:nvSpPr>
                <p:spPr>
                  <a:xfrm>
                    <a:off x="8885160" y="3498480"/>
                    <a:ext cx="328320" cy="15602040"/>
                  </a:xfrm>
                  <a:custGeom>
                    <a:avLst/>
                    <a:gdLst>
                      <a:gd name="textAreaLeft" fmla="*/ 0 w 328320"/>
                      <a:gd name="textAreaRight" fmla="*/ 118440 w 328320"/>
                      <a:gd name="textAreaTop" fmla="*/ 8280 h 15602040"/>
                      <a:gd name="textAreaBottom" fmla="*/ 15593760 h 1560204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19"/>
                          <a:pt x="10800" y="38"/>
                        </a:cubicBezTo>
                        <a:lnTo>
                          <a:pt x="10800" y="10762"/>
                        </a:lnTo>
                        <a:cubicBezTo>
                          <a:pt x="10800" y="10781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0819"/>
                          <a:pt x="10800" y="10838"/>
                        </a:cubicBezTo>
                        <a:lnTo>
                          <a:pt x="10800" y="21562"/>
                        </a:lnTo>
                        <a:cubicBezTo>
                          <a:pt x="10800" y="21581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25560">
                    <a:solidFill>
                      <a:srgbClr val="dd2fd5"/>
                    </a:solidFill>
                    <a:miter/>
                  </a:ln>
                  <a:effectLst>
                    <a:outerShdw dist="20160" dir="5400000" blurRad="0" rotWithShape="0">
                      <a:srgbClr val="808080">
                        <a:alpha val="38000"/>
                      </a:srgbClr>
                    </a:outerShdw>
                  </a:effectLst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" name="TextBox 17"/>
                  <p:cNvSpPr/>
                  <p:nvPr/>
                </p:nvSpPr>
                <p:spPr>
                  <a:xfrm>
                    <a:off x="9253440" y="11071080"/>
                    <a:ext cx="1400040" cy="307080"/>
                  </a:xfrm>
                  <a:prstGeom prst="rect">
                    <a:avLst/>
                  </a:prstGeom>
                  <a:solidFill>
                    <a:srgbClr val="dce6f2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400" spc="-1" strike="noStrike">
                        <a:solidFill>
                          <a:srgbClr val="0000ff"/>
                        </a:solidFill>
                        <a:latin typeface="Times New Roman"/>
                        <a:ea typeface="Times New Roman"/>
                      </a:rPr>
                      <a:t>Or-Hakuho_Str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" name="右大括号 22"/>
                  <p:cNvSpPr/>
                  <p:nvPr/>
                </p:nvSpPr>
                <p:spPr>
                  <a:xfrm>
                    <a:off x="8863200" y="22976280"/>
                    <a:ext cx="330120" cy="5224320"/>
                  </a:xfrm>
                  <a:custGeom>
                    <a:avLst/>
                    <a:gdLst>
                      <a:gd name="textAreaLeft" fmla="*/ 0 w 330120"/>
                      <a:gd name="textAreaRight" fmla="*/ 119160 w 330120"/>
                      <a:gd name="textAreaTop" fmla="*/ 8280 h 5224320"/>
                      <a:gd name="textAreaBottom" fmla="*/ 5216040 h 52243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57"/>
                          <a:pt x="10800" y="114"/>
                        </a:cubicBezTo>
                        <a:lnTo>
                          <a:pt x="10800" y="10686"/>
                        </a:lnTo>
                        <a:cubicBezTo>
                          <a:pt x="10800" y="10743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0857"/>
                          <a:pt x="10800" y="10914"/>
                        </a:cubicBezTo>
                        <a:lnTo>
                          <a:pt x="10800" y="21486"/>
                        </a:lnTo>
                        <a:cubicBezTo>
                          <a:pt x="10800" y="21543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25560">
                    <a:solidFill>
                      <a:srgbClr val="2a6855"/>
                    </a:solidFill>
                    <a:miter/>
                  </a:ln>
                  <a:effectLst>
                    <a:outerShdw dist="20160" dir="5400000" blurRad="0" rotWithShape="0">
                      <a:srgbClr val="808080">
                        <a:alpha val="38000"/>
                      </a:srgbClr>
                    </a:outerShdw>
                  </a:effectLst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" name="右大括号 23"/>
                  <p:cNvSpPr/>
                  <p:nvPr/>
                </p:nvSpPr>
                <p:spPr>
                  <a:xfrm>
                    <a:off x="8877240" y="28302480"/>
                    <a:ext cx="330120" cy="7118280"/>
                  </a:xfrm>
                  <a:custGeom>
                    <a:avLst/>
                    <a:gdLst>
                      <a:gd name="textAreaLeft" fmla="*/ 0 w 330120"/>
                      <a:gd name="textAreaRight" fmla="*/ 119160 w 330120"/>
                      <a:gd name="textAreaTop" fmla="*/ 8280 h 7118280"/>
                      <a:gd name="textAreaBottom" fmla="*/ 7110000 h 711828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42"/>
                          <a:pt x="10800" y="83"/>
                        </a:cubicBezTo>
                        <a:lnTo>
                          <a:pt x="10800" y="10717"/>
                        </a:lnTo>
                        <a:cubicBezTo>
                          <a:pt x="10800" y="10759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0842"/>
                          <a:pt x="10800" y="10883"/>
                        </a:cubicBezTo>
                        <a:lnTo>
                          <a:pt x="10800" y="21517"/>
                        </a:lnTo>
                        <a:cubicBezTo>
                          <a:pt x="10800" y="21559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25560">
                    <a:solidFill>
                      <a:srgbClr val="1cd225"/>
                    </a:solidFill>
                    <a:miter/>
                  </a:ln>
                  <a:effectLst>
                    <a:outerShdw dist="20160" dir="5400000" blurRad="0" rotWithShape="0">
                      <a:srgbClr val="808080">
                        <a:alpha val="38000"/>
                      </a:srgbClr>
                    </a:outerShdw>
                  </a:effectLst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" name="TextBox 18"/>
                  <p:cNvSpPr/>
                  <p:nvPr/>
                </p:nvSpPr>
                <p:spPr>
                  <a:xfrm>
                    <a:off x="9205920" y="25419240"/>
                    <a:ext cx="1447560" cy="307080"/>
                  </a:xfrm>
                  <a:prstGeom prst="rect">
                    <a:avLst/>
                  </a:prstGeom>
                  <a:solidFill>
                    <a:srgbClr val="dce6f2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400" spc="-1" strike="noStrike">
                        <a:solidFill>
                          <a:srgbClr val="0000ff"/>
                        </a:solidFill>
                        <a:latin typeface="Times New Roman"/>
                        <a:ea typeface="Times New Roman"/>
                      </a:rPr>
                      <a:t>Oc-Nectarine_Str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" name="TextBox 19"/>
                  <p:cNvSpPr/>
                  <p:nvPr/>
                </p:nvSpPr>
                <p:spPr>
                  <a:xfrm>
                    <a:off x="9217080" y="31704480"/>
                    <a:ext cx="1371600" cy="307080"/>
                  </a:xfrm>
                  <a:prstGeom prst="rect">
                    <a:avLst/>
                  </a:prstGeom>
                  <a:solidFill>
                    <a:srgbClr val="dce6f2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400" spc="-1" strike="noStrike">
                        <a:solidFill>
                          <a:srgbClr val="0000ff"/>
                        </a:solidFill>
                        <a:latin typeface="Times New Roman"/>
                        <a:ea typeface="Times New Roman"/>
                      </a:rPr>
                      <a:t>Oc-Peach_Str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" name="左大括号 26"/>
                  <p:cNvSpPr/>
                  <p:nvPr/>
                </p:nvSpPr>
                <p:spPr>
                  <a:xfrm rot="10800000">
                    <a:off x="8862840" y="19551960"/>
                    <a:ext cx="330120" cy="3371760"/>
                  </a:xfrm>
                  <a:custGeom>
                    <a:avLst/>
                    <a:gdLst>
                      <a:gd name="textAreaLeft" fmla="*/ 210960 w 330120"/>
                      <a:gd name="textAreaRight" fmla="*/ 330480 w 330120"/>
                      <a:gd name="textAreaTop" fmla="*/ 8280 h 3371760"/>
                      <a:gd name="textAreaBottom" fmla="*/ 3363480 h 33717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88"/>
                          <a:pt x="10800" y="176"/>
                        </a:cubicBezTo>
                        <a:lnTo>
                          <a:pt x="10800" y="10624"/>
                        </a:lnTo>
                        <a:cubicBezTo>
                          <a:pt x="10800" y="10712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0888"/>
                          <a:pt x="10800" y="10976"/>
                        </a:cubicBezTo>
                        <a:lnTo>
                          <a:pt x="10800" y="21424"/>
                        </a:lnTo>
                        <a:cubicBezTo>
                          <a:pt x="10800" y="21512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25560">
                    <a:solidFill>
                      <a:srgbClr val="ff0000"/>
                    </a:solidFill>
                    <a:miter/>
                  </a:ln>
                  <a:effectLst>
                    <a:outerShdw dist="20160" dir="5400000" blurRad="0" rotWithShape="0">
                      <a:srgbClr val="808080">
                        <a:alpha val="38000"/>
                      </a:srgbClr>
                    </a:outerShdw>
                  </a:effectLst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TextBox 9"/>
                  <p:cNvSpPr/>
                  <p:nvPr/>
                </p:nvSpPr>
                <p:spPr>
                  <a:xfrm>
                    <a:off x="9119160" y="21076200"/>
                    <a:ext cx="15408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Or-Nectarine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" name="右大括号 28"/>
                  <p:cNvSpPr/>
                  <p:nvPr/>
                </p:nvSpPr>
                <p:spPr>
                  <a:xfrm>
                    <a:off x="8915400" y="19183680"/>
                    <a:ext cx="233280" cy="312480"/>
                  </a:xfrm>
                  <a:custGeom>
                    <a:avLst/>
                    <a:gdLst>
                      <a:gd name="textAreaLeft" fmla="*/ 0 w 233280"/>
                      <a:gd name="textAreaRight" fmla="*/ 84240 w 233280"/>
                      <a:gd name="textAreaTop" fmla="*/ 5760 h 312480"/>
                      <a:gd name="textAreaBottom" fmla="*/ 306720 h 31248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672"/>
                          <a:pt x="10800" y="1343"/>
                        </a:cubicBezTo>
                        <a:lnTo>
                          <a:pt x="10800" y="9457"/>
                        </a:lnTo>
                        <a:cubicBezTo>
                          <a:pt x="10800" y="10129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1472"/>
                          <a:pt x="10800" y="12143"/>
                        </a:cubicBezTo>
                        <a:lnTo>
                          <a:pt x="10800" y="20257"/>
                        </a:lnTo>
                        <a:cubicBezTo>
                          <a:pt x="10800" y="20929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25560">
                    <a:solidFill>
                      <a:srgbClr val="d99694"/>
                    </a:solidFill>
                    <a:miter/>
                  </a:ln>
                  <a:effectLst>
                    <a:outerShdw dist="20160" dir="5400000" blurRad="0" rotWithShape="0">
                      <a:srgbClr val="808080">
                        <a:alpha val="38000"/>
                      </a:srgbClr>
                    </a:outerShdw>
                  </a:effectLst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" name="TextBox 6"/>
                  <p:cNvSpPr/>
                  <p:nvPr/>
                </p:nvSpPr>
                <p:spPr>
                  <a:xfrm>
                    <a:off x="9111960" y="19182960"/>
                    <a:ext cx="15408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Or-Yellow peach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" name="右大括号 30"/>
                  <p:cNvSpPr/>
                  <p:nvPr/>
                </p:nvSpPr>
                <p:spPr>
                  <a:xfrm>
                    <a:off x="8877240" y="35452440"/>
                    <a:ext cx="341280" cy="6531120"/>
                  </a:xfrm>
                  <a:custGeom>
                    <a:avLst/>
                    <a:gdLst>
                      <a:gd name="textAreaLeft" fmla="*/ 0 w 341280"/>
                      <a:gd name="textAreaRight" fmla="*/ 123120 w 341280"/>
                      <a:gd name="textAreaTop" fmla="*/ 8640 h 6531120"/>
                      <a:gd name="textAreaBottom" fmla="*/ 6522480 h 65311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47"/>
                          <a:pt x="10800" y="94"/>
                        </a:cubicBezTo>
                        <a:lnTo>
                          <a:pt x="10800" y="10706"/>
                        </a:lnTo>
                        <a:cubicBezTo>
                          <a:pt x="10800" y="10753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0847"/>
                          <a:pt x="10800" y="10894"/>
                        </a:cubicBezTo>
                        <a:lnTo>
                          <a:pt x="10800" y="21506"/>
                        </a:lnTo>
                        <a:cubicBezTo>
                          <a:pt x="10800" y="21553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25560">
                    <a:solidFill>
                      <a:srgbClr val="2c10fc"/>
                    </a:solidFill>
                    <a:miter/>
                  </a:ln>
                  <a:effectLst>
                    <a:outerShdw dist="20160" dir="5400000" blurRad="0" rotWithShape="0">
                      <a:srgbClr val="808080">
                        <a:alpha val="38000"/>
                      </a:srgbClr>
                    </a:outerShdw>
                  </a:effectLst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" name="TextBox 19"/>
                  <p:cNvSpPr/>
                  <p:nvPr/>
                </p:nvSpPr>
                <p:spPr>
                  <a:xfrm>
                    <a:off x="9221760" y="38562480"/>
                    <a:ext cx="1371600" cy="307080"/>
                  </a:xfrm>
                  <a:prstGeom prst="rect">
                    <a:avLst/>
                  </a:prstGeom>
                  <a:solidFill>
                    <a:srgbClr val="dce6f2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400" spc="-1" strike="noStrike">
                        <a:solidFill>
                          <a:srgbClr val="0000ff"/>
                        </a:solidFill>
                        <a:latin typeface="Times New Roman"/>
                        <a:ea typeface="Times New Roman"/>
                      </a:rPr>
                      <a:t>Landrace_Str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67" name="文本框 34"/>
                <p:cNvSpPr/>
                <p:nvPr/>
              </p:nvSpPr>
              <p:spPr>
                <a:xfrm>
                  <a:off x="1001520" y="10128240"/>
                  <a:ext cx="1117440" cy="368280"/>
                </a:xfrm>
                <a:prstGeom prst="rect">
                  <a:avLst/>
                </a:prstGeom>
                <a:solidFill>
                  <a:srgbClr val="e6b9b8"/>
                </a:solidFill>
                <a:ln w="936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Oriental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文本框 35"/>
                <p:cNvSpPr/>
                <p:nvPr/>
              </p:nvSpPr>
              <p:spPr>
                <a:xfrm>
                  <a:off x="1143000" y="26195760"/>
                  <a:ext cx="1257120" cy="368280"/>
                </a:xfrm>
                <a:prstGeom prst="rect">
                  <a:avLst/>
                </a:prstGeom>
                <a:solidFill>
                  <a:srgbClr val="ccff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Occidental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" name="文本框 36"/>
                <p:cNvSpPr/>
                <p:nvPr/>
              </p:nvSpPr>
              <p:spPr>
                <a:xfrm>
                  <a:off x="514440" y="38565720"/>
                  <a:ext cx="1257120" cy="368280"/>
                </a:xfrm>
                <a:prstGeom prst="rect">
                  <a:avLst/>
                </a:prstGeom>
                <a:solidFill>
                  <a:srgbClr val="95b3d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zh-CN" sz="1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L</a:t>
                  </a: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ndrace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0" name="直线连接符 4"/>
              <p:cNvSpPr/>
              <p:nvPr/>
            </p:nvSpPr>
            <p:spPr>
              <a:xfrm>
                <a:off x="8751960" y="41712120"/>
                <a:ext cx="0" cy="291960"/>
              </a:xfrm>
              <a:prstGeom prst="line">
                <a:avLst/>
              </a:prstGeom>
              <a:ln w="38160">
                <a:solidFill>
                  <a:srgbClr val="4f81b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直线连接符 72"/>
              <p:cNvSpPr/>
              <p:nvPr/>
            </p:nvSpPr>
            <p:spPr>
              <a:xfrm>
                <a:off x="8751960" y="38997360"/>
                <a:ext cx="0" cy="1741320"/>
              </a:xfrm>
              <a:prstGeom prst="line">
                <a:avLst/>
              </a:prstGeom>
              <a:ln w="38160">
                <a:solidFill>
                  <a:srgbClr val="9bbb5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直线连接符 74"/>
              <p:cNvSpPr/>
              <p:nvPr/>
            </p:nvSpPr>
            <p:spPr>
              <a:xfrm>
                <a:off x="8755200" y="36594000"/>
                <a:ext cx="0" cy="2276280"/>
              </a:xfrm>
              <a:prstGeom prst="line">
                <a:avLst/>
              </a:prstGeom>
              <a:ln w="38160">
                <a:solidFill>
                  <a:srgbClr val="c0504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直线连接符 3"/>
              <p:cNvSpPr/>
              <p:nvPr/>
            </p:nvSpPr>
            <p:spPr>
              <a:xfrm>
                <a:off x="7645320" y="3312720"/>
                <a:ext cx="647640" cy="0"/>
              </a:xfrm>
              <a:prstGeom prst="line">
                <a:avLst/>
              </a:prstGeom>
              <a:ln w="25560">
                <a:solidFill>
                  <a:srgbClr val="4f81b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4" name="直接连接符 64"/>
            <p:cNvSpPr/>
            <p:nvPr/>
          </p:nvSpPr>
          <p:spPr>
            <a:xfrm flipH="1">
              <a:off x="8861400" y="630000"/>
              <a:ext cx="2880" cy="9628200"/>
            </a:xfrm>
            <a:prstGeom prst="line">
              <a:avLst/>
            </a:prstGeom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直接连接符 67"/>
            <p:cNvSpPr/>
            <p:nvPr/>
          </p:nvSpPr>
          <p:spPr>
            <a:xfrm flipH="1">
              <a:off x="8859960" y="10488600"/>
              <a:ext cx="2880" cy="8612280"/>
            </a:xfrm>
            <a:prstGeom prst="line">
              <a:avLst/>
            </a:prstGeom>
            <a:ln w="25560">
              <a:solidFill>
                <a:srgbClr val="f7039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直接连接符 70"/>
            <p:cNvSpPr/>
            <p:nvPr/>
          </p:nvSpPr>
          <p:spPr>
            <a:xfrm flipH="1">
              <a:off x="8859960" y="19580040"/>
              <a:ext cx="1440" cy="3240000"/>
            </a:xfrm>
            <a:prstGeom prst="line">
              <a:avLst/>
            </a:prstGeom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直接连接符 75"/>
            <p:cNvSpPr/>
            <p:nvPr/>
          </p:nvSpPr>
          <p:spPr>
            <a:xfrm flipH="1">
              <a:off x="8858160" y="22977360"/>
              <a:ext cx="1440" cy="5224320"/>
            </a:xfrm>
            <a:prstGeom prst="line">
              <a:avLst/>
            </a:prstGeom>
            <a:ln w="25560">
              <a:solidFill>
                <a:srgbClr val="297f6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直接连接符 77"/>
            <p:cNvSpPr/>
            <p:nvPr/>
          </p:nvSpPr>
          <p:spPr>
            <a:xfrm flipH="1">
              <a:off x="8858160" y="28303560"/>
              <a:ext cx="1440" cy="7116840"/>
            </a:xfrm>
            <a:prstGeom prst="line">
              <a:avLst/>
            </a:prstGeom>
            <a:ln w="25560">
              <a:solidFill>
                <a:srgbClr val="1ff81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椭圆 79"/>
            <p:cNvSpPr/>
            <p:nvPr/>
          </p:nvSpPr>
          <p:spPr>
            <a:xfrm>
              <a:off x="1071720" y="41775480"/>
              <a:ext cx="14256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椭圆 80"/>
            <p:cNvSpPr/>
            <p:nvPr/>
          </p:nvSpPr>
          <p:spPr>
            <a:xfrm>
              <a:off x="2048040" y="39529080"/>
              <a:ext cx="14256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椭圆 81"/>
            <p:cNvSpPr/>
            <p:nvPr/>
          </p:nvSpPr>
          <p:spPr>
            <a:xfrm>
              <a:off x="2130480" y="35902800"/>
              <a:ext cx="14112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椭圆 82"/>
            <p:cNvSpPr/>
            <p:nvPr/>
          </p:nvSpPr>
          <p:spPr>
            <a:xfrm>
              <a:off x="4422600" y="29070360"/>
              <a:ext cx="14112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椭圆 83"/>
            <p:cNvSpPr/>
            <p:nvPr/>
          </p:nvSpPr>
          <p:spPr>
            <a:xfrm>
              <a:off x="3732120" y="23755320"/>
              <a:ext cx="14112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椭圆 84"/>
            <p:cNvSpPr/>
            <p:nvPr/>
          </p:nvSpPr>
          <p:spPr>
            <a:xfrm>
              <a:off x="3333600" y="22591800"/>
              <a:ext cx="14256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椭圆 85"/>
            <p:cNvSpPr/>
            <p:nvPr/>
          </p:nvSpPr>
          <p:spPr>
            <a:xfrm>
              <a:off x="3333600" y="12648960"/>
              <a:ext cx="14256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椭圆 86"/>
            <p:cNvSpPr/>
            <p:nvPr/>
          </p:nvSpPr>
          <p:spPr>
            <a:xfrm>
              <a:off x="3414600" y="5638680"/>
              <a:ext cx="14256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椭圆 87"/>
            <p:cNvSpPr/>
            <p:nvPr/>
          </p:nvSpPr>
          <p:spPr>
            <a:xfrm>
              <a:off x="2673360" y="5352840"/>
              <a:ext cx="66024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椭圆 88"/>
            <p:cNvSpPr/>
            <p:nvPr/>
          </p:nvSpPr>
          <p:spPr>
            <a:xfrm>
              <a:off x="2599560" y="12507480"/>
              <a:ext cx="66024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椭圆 89"/>
            <p:cNvSpPr/>
            <p:nvPr/>
          </p:nvSpPr>
          <p:spPr>
            <a:xfrm>
              <a:off x="3033720" y="22096440"/>
              <a:ext cx="50796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椭圆 90"/>
            <p:cNvSpPr/>
            <p:nvPr/>
          </p:nvSpPr>
          <p:spPr>
            <a:xfrm>
              <a:off x="3160800" y="23498280"/>
              <a:ext cx="50796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椭圆 91"/>
            <p:cNvSpPr/>
            <p:nvPr/>
          </p:nvSpPr>
          <p:spPr>
            <a:xfrm>
              <a:off x="3879000" y="28847880"/>
              <a:ext cx="50940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椭圆 92"/>
            <p:cNvSpPr/>
            <p:nvPr/>
          </p:nvSpPr>
          <p:spPr>
            <a:xfrm>
              <a:off x="1540800" y="35668800"/>
              <a:ext cx="50796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椭圆 93"/>
            <p:cNvSpPr/>
            <p:nvPr/>
          </p:nvSpPr>
          <p:spPr>
            <a:xfrm>
              <a:off x="1427760" y="39301200"/>
              <a:ext cx="50796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椭圆 94"/>
            <p:cNvSpPr/>
            <p:nvPr/>
          </p:nvSpPr>
          <p:spPr>
            <a:xfrm>
              <a:off x="368280" y="41589720"/>
              <a:ext cx="507960" cy="514080"/>
            </a:xfrm>
            <a:prstGeom prst="ellipse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5" name="文本框 69"/>
          <p:cNvSpPr/>
          <p:nvPr/>
        </p:nvSpPr>
        <p:spPr>
          <a:xfrm>
            <a:off x="314280" y="1074600"/>
            <a:ext cx="2286000" cy="2756880"/>
          </a:xfrm>
          <a:prstGeom prst="rect">
            <a:avLst/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fferent color of  </a:t>
            </a:r>
            <a:r>
              <a:rPr b="1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essions’ name indicated the accession was assigned to the specified subpopulation</a:t>
            </a:r>
            <a:r>
              <a:rPr b="1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：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800000"/>
                </a:solidFill>
                <a:latin typeface="Times New Roman"/>
                <a:ea typeface="Times New Roman"/>
              </a:rPr>
              <a:t> ‘</a:t>
            </a:r>
            <a:r>
              <a:rPr b="1" lang="en-US" sz="1000" spc="-1" strike="noStrike">
                <a:solidFill>
                  <a:srgbClr val="800000"/>
                </a:solidFill>
                <a:latin typeface="Times New Roman"/>
                <a:ea typeface="Times New Roman"/>
              </a:rPr>
              <a:t>Yu Lu’ population                           </a:t>
            </a:r>
            <a:r>
              <a:rPr b="1" lang="en-US" sz="1000" spc="-1" strike="noStrike">
                <a:solidFill>
                  <a:srgbClr val="de23f7"/>
                </a:solidFill>
                <a:latin typeface="Times New Roman"/>
                <a:ea typeface="Times New Roman"/>
              </a:rPr>
              <a:t>‘Hakuho’ population         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                </a:t>
            </a:r>
            <a:r>
              <a:rPr b="1" lang="en-US" sz="1000" spc="-1" strike="noStrike">
                <a:solidFill>
                  <a:srgbClr val="1ff814"/>
                </a:solidFill>
                <a:latin typeface="Times New Roman"/>
                <a:ea typeface="Times New Roman"/>
              </a:rPr>
              <a:t>‘</a:t>
            </a:r>
            <a:r>
              <a:rPr b="1" lang="en-US" sz="1000" spc="-1" strike="noStrike">
                <a:solidFill>
                  <a:srgbClr val="1ff814"/>
                </a:solidFill>
                <a:latin typeface="Times New Roman"/>
                <a:ea typeface="Times New Roman"/>
              </a:rPr>
              <a:t>Oc_Nectarine’ population               </a:t>
            </a:r>
            <a:r>
              <a:rPr b="1" lang="en-US" sz="1000" spc="-1" strike="noStrike">
                <a:solidFill>
                  <a:srgbClr val="297f62"/>
                </a:solidFill>
                <a:latin typeface="Times New Roman"/>
                <a:ea typeface="Times New Roman"/>
              </a:rPr>
              <a:t>‘Oc_Peach’ popul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297f62"/>
                </a:solidFill>
                <a:latin typeface="Times New Roman"/>
                <a:ea typeface="Times New Roman"/>
              </a:rPr>
              <a:t>                                                        </a:t>
            </a:r>
            <a:r>
              <a:rPr b="1" lang="en-US" sz="10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landrace population                          </a:t>
            </a: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unstructure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1T15:42:39Z</dcterms:created>
  <dc:creator>xiongwei li</dc:creator>
  <dc:description/>
  <dc:language>en-US</dc:language>
  <cp:lastModifiedBy>xiongwei li</cp:lastModifiedBy>
  <dcterms:modified xsi:type="dcterms:W3CDTF">2013-07-04T18:33:48Z</dcterms:modified>
  <cp:revision>38</cp:revision>
  <dc:subject/>
  <dc:title>PowerPoint 演示文稿</dc:title>
</cp:coreProperties>
</file>